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39B095-6368-4476-A02A-95FCE5F2F04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97F2A6-4A43-432F-8E79-B12BC64E21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88763A-2A4E-46E5-9335-08761D4A704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7AD7FE-4346-4201-8DFA-B54A6895E83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9B305B-D8E9-42B6-AF20-A8575B0F33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BB6BB6-32A5-4AD2-B298-3E3A9ACA61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4DF669-F470-404F-83DA-4D6709A636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0EA0EA-F3B3-4F5F-BF5E-222FC2EF90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174970-1C19-468B-A0A5-C4FC317F97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83B1CF-6E5B-4712-B752-C795121111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4045E2-67A3-4293-BA57-3748FC3F94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7B7087-8408-47FB-81DB-78DD0D0E56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66CE02-B963-4253-9F66-9ADA0720F8B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13840" y="1117440"/>
            <a:ext cx="6253200" cy="2512800"/>
            <a:chOff x="213840" y="1117440"/>
            <a:chExt cx="6253200" cy="2512800"/>
          </a:xfrm>
        </p:grpSpPr>
        <p:sp>
          <p:nvSpPr>
            <p:cNvPr id="42" name=""/>
            <p:cNvSpPr/>
            <p:nvPr/>
          </p:nvSpPr>
          <p:spPr>
            <a:xfrm>
              <a:off x="1935000" y="1117440"/>
              <a:ext cx="2876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virulence factor MviN 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Verrucomicrobium spinosum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DSM 4136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 flipV="1">
              <a:off x="523080" y="1165320"/>
              <a:ext cx="1413360" cy="80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480" bIns="33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844360" y="1278000"/>
              <a:ext cx="3437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integral membrane protein MviN 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Akkermansia muciniphil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ATCC BAA 835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523080" y="1246320"/>
              <a:ext cx="2321280" cy="80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480" bIns="33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 flipV="1">
              <a:off x="368640" y="1245960"/>
              <a:ext cx="154080" cy="160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206800" y="1438200"/>
              <a:ext cx="2617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virulence factor  MviN  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Desulfotalea psychrophil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LSv54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 flipV="1">
              <a:off x="1070280" y="1487520"/>
              <a:ext cx="1136520" cy="79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425680" y="1598760"/>
              <a:ext cx="2690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Virulence factor MVIN like  delta proteobacterium MLMS 1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070280" y="1567800"/>
              <a:ext cx="1355040" cy="80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480" bIns="33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flipV="1">
              <a:off x="659520" y="1567800"/>
              <a:ext cx="410760" cy="160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185920" y="1758600"/>
              <a:ext cx="317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integral membrane protein MviN 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Haliangium ochraceum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DSM 14365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flipV="1">
              <a:off x="972000" y="1808640"/>
              <a:ext cx="1210320" cy="80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480" bIns="33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198520" y="1920600"/>
              <a:ext cx="3008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integral membrane protein MviN 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Anaeromyxobacter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sp  Fw109 5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flipV="1">
              <a:off x="1751040" y="1969200"/>
              <a:ext cx="443520" cy="80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480" bIns="33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171520" y="2081160"/>
              <a:ext cx="3420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integral membrane protein MviN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Anaeromyxobacter dehalogenans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2CP C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flipV="1">
              <a:off x="2089440" y="2129760"/>
              <a:ext cx="77400" cy="80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480" bIns="33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159640" y="2241360"/>
              <a:ext cx="3403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integral membrane protein MviN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Anaeromyxobacter dehalogenans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2CP 1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flipV="1">
              <a:off x="2149920" y="2290680"/>
              <a:ext cx="5040" cy="80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480" bIns="33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156040" y="2403360"/>
              <a:ext cx="2687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integral membrane protein MviN  Anaeromyxobacter sp  K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149920" y="2371680"/>
              <a:ext cx="5040" cy="80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480" bIns="33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089440" y="2210760"/>
              <a:ext cx="60120" cy="160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751040" y="2050200"/>
              <a:ext cx="338400" cy="160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972000" y="1889640"/>
              <a:ext cx="779040" cy="160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659520" y="1728360"/>
              <a:ext cx="312480" cy="160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465840" y="1728360"/>
              <a:ext cx="193680" cy="803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191680" y="2563920"/>
              <a:ext cx="4275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Uncharacterized membrane protein putative virulence factor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Methylacidiphilum infernorum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V4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flipV="1">
              <a:off x="608040" y="2612880"/>
              <a:ext cx="1580400" cy="79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569960" y="2723760"/>
              <a:ext cx="2946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integral membrane protein MviN 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Chthoniobacter flavus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Ellin428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flipV="1">
              <a:off x="783360" y="2773080"/>
              <a:ext cx="783360" cy="80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480" bIns="33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764720" y="2884680"/>
              <a:ext cx="2902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virulence factor MviN 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Legionella pneumophil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str  Philadelphia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 flipV="1">
              <a:off x="1757520" y="2933640"/>
              <a:ext cx="4320" cy="80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480" bIns="33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1766880" y="3046320"/>
              <a:ext cx="324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virulence factor MviN  lpa01685 </a:t>
              </a: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Legionella pneumophila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str Alcoy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flipV="1">
              <a:off x="1760760" y="3094200"/>
              <a:ext cx="4320" cy="80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480" bIns="33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765440" y="3206520"/>
              <a:ext cx="2619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virulence factor MviN 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Legionella pneumophil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str  Corby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760760" y="3175200"/>
              <a:ext cx="2160" cy="79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757520" y="3014640"/>
              <a:ext cx="2880" cy="160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783360" y="2854080"/>
              <a:ext cx="974160" cy="160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608040" y="2692800"/>
              <a:ext cx="174960" cy="160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465840" y="2532240"/>
              <a:ext cx="142200" cy="160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68640" y="1406880"/>
              <a:ext cx="96840" cy="1125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13840" y="1406880"/>
              <a:ext cx="154800" cy="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677880" y="3476880"/>
              <a:ext cx="316800" cy="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677880" y="3452400"/>
              <a:ext cx="720" cy="48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" bIns="1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994680" y="3452400"/>
              <a:ext cx="360" cy="48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" bIns="1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787320" y="350820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7" name=""/>
          <p:cNvSpPr/>
          <p:nvPr/>
        </p:nvSpPr>
        <p:spPr>
          <a:xfrm>
            <a:off x="2938320" y="5006880"/>
            <a:ext cx="3289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putative virulence factor MviN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egionella pneumophil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tr  Philadelphia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flipV="1">
            <a:off x="2925720" y="5052600"/>
            <a:ext cx="11160" cy="7452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2965680" y="5156280"/>
            <a:ext cx="2855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hypothetical protein lpl2560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egionella pneumophil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tr  Lens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flipV="1">
            <a:off x="2936880" y="5200560"/>
            <a:ext cx="23760" cy="7488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2960640" y="5303880"/>
            <a:ext cx="3272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virulence factor MviN  lpa03855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egionella pneumophila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tr  Alcoy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flipV="1">
            <a:off x="2959200" y="5349600"/>
            <a:ext cx="0" cy="7308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2973240" y="5451480"/>
            <a:ext cx="2900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hypothetical protein lpp2688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egionella pneumophil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tr  Paris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flipV="1">
            <a:off x="2967120" y="5495760"/>
            <a:ext cx="1440" cy="7488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3082320" y="5599080"/>
            <a:ext cx="2852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integral membrane protein  </a:t>
            </a:r>
            <a:r>
              <a:rPr b="0" i="1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Legionella pneumophila</a:t>
            </a:r>
            <a:r>
              <a:rPr b="0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 str  Corby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2967120" y="5570640"/>
            <a:ext cx="109440" cy="7308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2959200" y="5423040"/>
            <a:ext cx="7920" cy="1476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2936880" y="5275440"/>
            <a:ext cx="22320" cy="1476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2925720" y="5127480"/>
            <a:ext cx="11160" cy="1479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 flipV="1">
            <a:off x="808200" y="5127120"/>
            <a:ext cx="2117520" cy="5907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2657880" y="5746680"/>
            <a:ext cx="2353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integral membrane protein MviN  </a:t>
            </a:r>
            <a:r>
              <a:rPr b="0" i="1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Rickettsiella grylli</a:t>
            </a:r>
            <a:r>
              <a:rPr b="0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 flipV="1">
            <a:off x="878040" y="5792400"/>
            <a:ext cx="1780920" cy="7308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869560" y="5894280"/>
            <a:ext cx="3133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integral membrane protein MviN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oxiella burnetii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 MSU Goat Q177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 flipV="1">
            <a:off x="2863800" y="5940000"/>
            <a:ext cx="3240" cy="7308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2873880" y="6041880"/>
            <a:ext cx="2435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virulence factor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oxiella burnetii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Dugway 5J108 111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 flipV="1">
            <a:off x="2870280" y="6087600"/>
            <a:ext cx="1440" cy="7308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2894400" y="6189840"/>
            <a:ext cx="1972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virulence factor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oxiella burnetii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RSA 493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flipV="1">
            <a:off x="2892600" y="6235200"/>
            <a:ext cx="0" cy="7308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2937600" y="6337440"/>
            <a:ext cx="1646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MviN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oxiella burnetii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CbuG Q212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2892600" y="6308640"/>
            <a:ext cx="44280" cy="7452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2870280" y="6161040"/>
            <a:ext cx="22320" cy="1476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863800" y="6013440"/>
            <a:ext cx="6480" cy="1476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878040" y="5865840"/>
            <a:ext cx="1985760" cy="1476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808200" y="5718240"/>
            <a:ext cx="69840" cy="1476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666720" y="5718240"/>
            <a:ext cx="141480" cy="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1092240" y="6586560"/>
            <a:ext cx="549360" cy="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092240" y="6562800"/>
            <a:ext cx="0" cy="4608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1641600" y="6562800"/>
            <a:ext cx="0" cy="4608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1322280" y="662004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MS Mincho"/>
              </a:rPr>
              <a:t>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592560" y="425880"/>
            <a:ext cx="5383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8604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a) Mvin gene on  phage related islands PR1/PR6 (Alcoy/Corby/Philadelphia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8604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594720" y="4416840"/>
            <a:ext cx="5695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8604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b) Chromosomal Mvin gene of Alcoy, Corby, Philadelphia, Lens and Paris strain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8604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611280" y="5985360"/>
            <a:ext cx="1807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1200"/>
            </a:b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09T09:41:44Z</dcterms:created>
  <dc:creator>gdauria</dc:creator>
  <dc:description/>
  <dc:language>en-US</dc:language>
  <cp:lastModifiedBy>gdauria</cp:lastModifiedBy>
  <dcterms:modified xsi:type="dcterms:W3CDTF">2009-09-09T09:44:03Z</dcterms:modified>
  <cp:revision>1</cp:revision>
  <dc:subject/>
  <dc:title>Diapositiva 1</dc:title>
</cp:coreProperties>
</file>